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44DD2-8373-4FB1-9BE7-2D99491DF3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52C93C-911F-4A5F-AE6B-B7CAB4E68A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0FD918-CCA2-4D16-9EC2-CE8911E161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60CFB-D64C-4483-B743-0901C8CABC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638E3-88A6-40BD-A2C0-A3A98D58B9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F908D-8652-4BEE-A398-5133B4AC77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69A7C-0508-4CFB-A5FB-6ED792FB8A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6B252-FE5D-4904-A09F-ACB1F771F2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00CD7-405B-461E-8BF9-F4A05D8947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D6D06-7C76-4245-A717-697F103C07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D164A-06F0-4799-AF12-42D167F039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A31F77-942A-42FC-859D-6532968C86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1604AB-CCAA-428F-BF78-1DA4CFA335C5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6320" y="838080"/>
            <a:ext cx="8915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3.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ctivity based protein profiling (ABPP) of normal male (A) and female (B) urines at different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emperatures, pH 9.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0" t="7428" r="0" b="50493"/>
          <a:stretch/>
        </p:blipFill>
        <p:spPr>
          <a:xfrm>
            <a:off x="380880" y="2057400"/>
            <a:ext cx="4103640" cy="12952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rcRect l="0" t="55444" r="0" b="2478"/>
          <a:stretch/>
        </p:blipFill>
        <p:spPr>
          <a:xfrm>
            <a:off x="4572000" y="3429000"/>
            <a:ext cx="4103640" cy="12952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rcRect l="0" t="54462" r="0" b="3454"/>
          <a:stretch/>
        </p:blipFill>
        <p:spPr>
          <a:xfrm>
            <a:off x="4572000" y="2057400"/>
            <a:ext cx="4103640" cy="129528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rcRect l="0" t="7428" r="0" b="50493"/>
          <a:stretch/>
        </p:blipFill>
        <p:spPr>
          <a:xfrm>
            <a:off x="380880" y="3429000"/>
            <a:ext cx="4103640" cy="12952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421920" y="1706400"/>
            <a:ext cx="106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 Male, n=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611600" y="1706400"/>
            <a:ext cx="125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 Female, n=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085760" y="2057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20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439720" y="2057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37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627360" y="2057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60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259240" y="2057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20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613560" y="2057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37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818480" y="2057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60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085760" y="3443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20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439720" y="3443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37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627360" y="3443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60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259240" y="3443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20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6613560" y="3443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37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7818480" y="3443400"/>
            <a:ext cx="4078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ffffff"/>
                </a:solidFill>
                <a:latin typeface="Arial"/>
              </a:rPr>
              <a:t>60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7T17:43:52Z</dcterms:created>
  <dc:creator>Winnipeg Regional Health Authority</dc:creator>
  <dc:description/>
  <dc:language>en-US</dc:language>
  <cp:lastModifiedBy>Winnipeg Regional Health Authority</cp:lastModifiedBy>
  <dcterms:modified xsi:type="dcterms:W3CDTF">2013-09-23T22:05:20Z</dcterms:modified>
  <cp:revision>549</cp:revision>
  <dc:subject/>
  <dc:title>NOVEL BIOMARKERS OF IFTA,  RENAL ALLOGRAFT DYSFUNCTION AND LOSS</dc:title>
</cp:coreProperties>
</file>